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9144000" cy="6858000"/>
  <p:notesSz cx="6886575" cy="100187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86800" cy="1001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-360"/>
            <a:ext cx="2984400" cy="5000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02040" y="-360"/>
            <a:ext cx="2984400" cy="5000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42840" y="752400"/>
            <a:ext cx="5005440" cy="37562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9040" y="4759200"/>
            <a:ext cx="5510160" cy="45086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518400"/>
            <a:ext cx="2984400" cy="5000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02040" y="9518400"/>
            <a:ext cx="2984400" cy="5000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b">
            <a:noAutofit/>
          </a:bodyPr>
          <a:lstStyle>
            <a:lvl1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  <a:defRPr b="0" lang="de-DE" sz="13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94ACC7A5-2501-4E35-99CD-183B25C0D4CA}" type="slidenum">
              <a:rPr b="0" lang="de-DE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Rectangle 7"/>
          <p:cNvSpPr/>
          <p:nvPr/>
        </p:nvSpPr>
        <p:spPr>
          <a:xfrm>
            <a:off x="3902040" y="9518760"/>
            <a:ext cx="298440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77419AF6-3375-4C35-9DE4-B2D47E54A0B6}" type="slidenum">
              <a:rPr b="0" lang="de-DE" sz="13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1"/>
          <p:cNvSpPr>
            <a:spLocks noGrp="1"/>
          </p:cNvSpPr>
          <p:nvPr>
            <p:ph type="sldImg"/>
          </p:nvPr>
        </p:nvSpPr>
        <p:spPr>
          <a:xfrm>
            <a:off x="942840" y="752400"/>
            <a:ext cx="5005440" cy="3756240"/>
          </a:xfrm>
          <a:prstGeom prst="rect">
            <a:avLst/>
          </a:prstGeom>
          <a:ln w="0">
            <a:noFill/>
          </a:ln>
        </p:spPr>
      </p:sp>
      <p:sp>
        <p:nvSpPr>
          <p:cNvPr id="144" name="PlaceHolder 2"/>
          <p:cNvSpPr>
            <a:spLocks noGrp="1"/>
          </p:cNvSpPr>
          <p:nvPr>
            <p:ph type="body"/>
          </p:nvPr>
        </p:nvSpPr>
        <p:spPr>
          <a:xfrm>
            <a:off x="689040" y="4759200"/>
            <a:ext cx="5510160" cy="4508640"/>
          </a:xfrm>
          <a:prstGeom prst="rect">
            <a:avLst/>
          </a:prstGeom>
          <a:noFill/>
          <a:ln w="0">
            <a:noFill/>
          </a:ln>
        </p:spPr>
        <p:txBody>
          <a:bodyPr lIns="96480" rIns="96480" tIns="48240" bIns="482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oliennummernplatzhalter 3"/>
          <p:cNvSpPr/>
          <p:nvPr/>
        </p:nvSpPr>
        <p:spPr>
          <a:xfrm>
            <a:off x="3902040" y="9518760"/>
            <a:ext cx="2984400" cy="50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6480" rIns="96480" tIns="48240" bIns="4824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66960"/>
                <a:tab algn="l" pos="1933560"/>
                <a:tab algn="l" pos="2900520"/>
                <a:tab algn="l" pos="3867120"/>
                <a:tab algn="l" pos="4834080"/>
                <a:tab algn="l" pos="5800680"/>
                <a:tab algn="l" pos="6767640"/>
                <a:tab algn="l" pos="7734240"/>
                <a:tab algn="l" pos="8701200"/>
                <a:tab algn="l" pos="9667800"/>
                <a:tab algn="l" pos="10634760"/>
              </a:tabLst>
            </a:pPr>
            <a:fld id="{1CBD005D-414C-433B-A227-920BF3463BE7}" type="slidenum">
              <a:rPr b="0" lang="de-DE" sz="13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D7EFA-4B68-4D97-91F2-6E0A5618FA3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73A6E-28AB-405A-B315-14D32C424A6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9CDE7E-F209-4A0C-B996-774AD1F37CE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754E67-E2C1-4AF3-AD57-1C10C29A4E3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394D77-E6E1-49A3-BE49-BDA728ECF2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A4252-BA4A-4239-A4DC-3D09330ED7C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93E42A-0462-41C3-B9E0-D61E3912DF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F1F2F6-7338-481E-8D92-3479F1FA0B3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28092-B9F5-4067-AB14-4ACA794F67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14728C-100C-4365-AFB5-062E4C72EB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866F9D-0D4E-4666-A232-0D7F5D30F4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4E84A0-4DB2-497A-AAB7-FD049563F5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557280" indent="-21420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857160" indent="-171360">
              <a:spcBef>
                <a:spcPts val="6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200240" indent="-171360">
              <a:spcBef>
                <a:spcPts val="601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542960" indent="-171360">
              <a:spcBef>
                <a:spcPts val="601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0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5CC3B08-27F6-45B2-BFDB-F5F33C7139D8}" type="slidenum">
              <a:rPr b="0" lang="de-DE" sz="10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1.xml"/><Relationship Id="rId11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image" Target="../media/image11.png"/><Relationship Id="rId3" Type="http://schemas.openxmlformats.org/officeDocument/2006/relationships/image" Target="../media/image12.png"/><Relationship Id="rId4" Type="http://schemas.openxmlformats.org/officeDocument/2006/relationships/image" Target="../media/image13.png"/><Relationship Id="rId5" Type="http://schemas.openxmlformats.org/officeDocument/2006/relationships/image" Target="../media/image1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en 2"/>
          <p:cNvGrpSpPr/>
          <p:nvPr/>
        </p:nvGrpSpPr>
        <p:grpSpPr>
          <a:xfrm>
            <a:off x="141120" y="1052640"/>
            <a:ext cx="9033480" cy="3216240"/>
            <a:chOff x="141120" y="1052640"/>
            <a:chExt cx="9033480" cy="3216240"/>
          </a:xfrm>
        </p:grpSpPr>
        <p:sp>
          <p:nvSpPr>
            <p:cNvPr id="49" name="Rechteck 1"/>
            <p:cNvSpPr/>
            <p:nvPr/>
          </p:nvSpPr>
          <p:spPr>
            <a:xfrm>
              <a:off x="141120" y="1052640"/>
              <a:ext cx="9002880" cy="32162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feld 16"/>
            <p:cNvSpPr/>
            <p:nvPr/>
          </p:nvSpPr>
          <p:spPr>
            <a:xfrm>
              <a:off x="141120" y="1177920"/>
              <a:ext cx="33138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pplementary Figure 1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" name="Gruppieren 6"/>
            <p:cNvGrpSpPr/>
            <p:nvPr/>
          </p:nvGrpSpPr>
          <p:grpSpPr>
            <a:xfrm>
              <a:off x="141120" y="1701720"/>
              <a:ext cx="9033480" cy="2448360"/>
              <a:chOff x="141120" y="1701720"/>
              <a:chExt cx="9033480" cy="2448360"/>
            </a:xfrm>
          </p:grpSpPr>
          <p:grpSp>
            <p:nvGrpSpPr>
              <p:cNvPr id="52" name="Gruppieren 3"/>
              <p:cNvGrpSpPr/>
              <p:nvPr/>
            </p:nvGrpSpPr>
            <p:grpSpPr>
              <a:xfrm>
                <a:off x="141120" y="1844640"/>
                <a:ext cx="3126600" cy="1873440"/>
                <a:chOff x="141120" y="1844640"/>
                <a:chExt cx="3126600" cy="1873440"/>
              </a:xfrm>
            </p:grpSpPr>
            <p:pic>
              <p:nvPicPr>
                <p:cNvPr id="53" name="Picture 49" descr="\\cr.uni-frankfurt.de\homes\fb14\asfischer\Documents\Ongoing projects\PGE2 Hemmung Lukaste 5LOInhibitoren\WB protein expression\cPLA2a.tif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141120" y="1844640"/>
                  <a:ext cx="2718360" cy="144540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54" name="Textfeld 9"/>
                <p:cNvSpPr/>
                <p:nvPr/>
              </p:nvSpPr>
              <p:spPr>
                <a:xfrm>
                  <a:off x="2710440" y="3302640"/>
                  <a:ext cx="557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10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Textfeld 15"/>
                <p:cNvSpPr/>
                <p:nvPr/>
              </p:nvSpPr>
              <p:spPr>
                <a:xfrm>
                  <a:off x="265680" y="3513600"/>
                  <a:ext cx="531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el-GR" sz="700" spc="-1" strike="noStrike">
                      <a:solidFill>
                        <a:srgbClr val="000000"/>
                      </a:solidFill>
                      <a:latin typeface="Arial"/>
                    </a:rPr>
                    <a:t>β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-Actin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56" name="Picture 46" descr=""/>
                <p:cNvPicPr/>
                <p:nvPr/>
              </p:nvPicPr>
              <p:blipFill>
                <a:blip r:embed="rId2"/>
                <a:srcRect l="7536" t="0" r="17480" b="0"/>
                <a:stretch/>
              </p:blipFill>
              <p:spPr>
                <a:xfrm>
                  <a:off x="730800" y="3309480"/>
                  <a:ext cx="2064240" cy="16668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57" name="Picture 48" descr=""/>
                <p:cNvPicPr/>
                <p:nvPr/>
              </p:nvPicPr>
              <p:blipFill>
                <a:blip r:embed="rId3">
                  <a:lum contrast="42000"/>
                </a:blip>
                <a:srcRect l="6884" t="0" r="15438" b="-10892"/>
                <a:stretch/>
              </p:blipFill>
              <p:spPr>
                <a:xfrm>
                  <a:off x="738000" y="3532320"/>
                  <a:ext cx="2057040" cy="17568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58" name="Textfeld 9"/>
                <p:cNvSpPr/>
                <p:nvPr/>
              </p:nvSpPr>
              <p:spPr>
                <a:xfrm>
                  <a:off x="2731320" y="3517560"/>
                  <a:ext cx="5324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42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9" name="Gruppieren 2"/>
              <p:cNvGrpSpPr/>
              <p:nvPr/>
            </p:nvGrpSpPr>
            <p:grpSpPr>
              <a:xfrm>
                <a:off x="3060000" y="1838880"/>
                <a:ext cx="3090960" cy="1878840"/>
                <a:chOff x="3060000" y="1838880"/>
                <a:chExt cx="3090960" cy="1878840"/>
              </a:xfrm>
            </p:grpSpPr>
            <p:pic>
              <p:nvPicPr>
                <p:cNvPr id="60" name="Picture 43" descr="\\cr.uni-frankfurt.de\homes\fb14\asfischer\Documents\Ongoing projects\PGE2 Hemmung Lukaste 5LOInhibitoren\WB protein expression\COX-2 5-LO Inhib SD.tif"/>
                <p:cNvPicPr/>
                <p:nvPr/>
              </p:nvPicPr>
              <p:blipFill>
                <a:blip r:embed="rId4"/>
                <a:srcRect l="0" t="0" r="0" b="33204"/>
                <a:stretch/>
              </p:blipFill>
              <p:spPr>
                <a:xfrm>
                  <a:off x="3060000" y="1838880"/>
                  <a:ext cx="2739240" cy="148464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1" name="Picture 47" descr="\\cr.uni-frankfurt.de\homes\fb14\asfischer\Documents\Ongoing projects\PGE2 Hemmung Lukaste 5LOInhibitoren\WB protein expression\COX expression\180625\180625_Hela_5LOInhibitoren_COX2.tif"/>
                <p:cNvPicPr/>
                <p:nvPr/>
              </p:nvPicPr>
              <p:blipFill>
                <a:blip r:embed="rId5"/>
                <a:srcRect l="24441" t="32628" r="14046" b="58380"/>
                <a:stretch/>
              </p:blipFill>
              <p:spPr>
                <a:xfrm>
                  <a:off x="3644640" y="3309840"/>
                  <a:ext cx="2079360" cy="16668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62" name="Picture 48" descr="\\cr.uni-frankfurt.de\homes\fb14\asfischer\Documents\Ongoing projects\PGE2 Hemmung Lukaste 5LOInhibitoren\WB protein expression\COX expression\180625\180625_Hela_5LOInhibitoren_COX2_Actin.tif"/>
                <p:cNvPicPr/>
                <p:nvPr/>
              </p:nvPicPr>
              <p:blipFill>
                <a:blip r:embed="rId6"/>
                <a:srcRect l="24877" t="52345" r="13062" b="39976"/>
                <a:stretch/>
              </p:blipFill>
              <p:spPr>
                <a:xfrm>
                  <a:off x="3639960" y="3533040"/>
                  <a:ext cx="2084040" cy="1656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63" name="Textfeld 9"/>
                <p:cNvSpPr/>
                <p:nvPr/>
              </p:nvSpPr>
              <p:spPr>
                <a:xfrm>
                  <a:off x="5617800" y="3517200"/>
                  <a:ext cx="5324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42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Textfeld 9"/>
                <p:cNvSpPr/>
                <p:nvPr/>
              </p:nvSpPr>
              <p:spPr>
                <a:xfrm>
                  <a:off x="5642640" y="3304440"/>
                  <a:ext cx="508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72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5" name="Gruppieren 1"/>
              <p:cNvGrpSpPr/>
              <p:nvPr/>
            </p:nvGrpSpPr>
            <p:grpSpPr>
              <a:xfrm>
                <a:off x="5925600" y="1845360"/>
                <a:ext cx="3249000" cy="1870560"/>
                <a:chOff x="5925600" y="1845360"/>
                <a:chExt cx="3249000" cy="1870560"/>
              </a:xfrm>
            </p:grpSpPr>
            <p:pic>
              <p:nvPicPr>
                <p:cNvPr id="66" name="Picture 44" descr="\\cr.uni-frankfurt.de\homes\fb14\asfischer\Documents\Ongoing projects\PGE2 Hemmung Lukaste 5LOInhibitoren\WB protein expression\mPGES-1 5-LO Inhib SD.tif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5925600" y="1845360"/>
                  <a:ext cx="2843640" cy="144468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67" name="Picture 49" descr="\\cr.uni-frankfurt.de\homes\fb14\asfischer\Documents\Ongoing projects\PGE2 Hemmung Lukaste 5LOInhibitoren\WB protein expression\mPGES1 expression\180625\180625_Hela_5LOInhibitoren_mPGES1.tif"/>
                <p:cNvPicPr/>
                <p:nvPr/>
              </p:nvPicPr>
              <p:blipFill>
                <a:blip r:embed="rId8"/>
                <a:srcRect l="20320" t="53350" r="16061" b="36473"/>
                <a:stretch/>
              </p:blipFill>
              <p:spPr>
                <a:xfrm>
                  <a:off x="6517440" y="3311280"/>
                  <a:ext cx="2224080" cy="16524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68" name="Picture 50" descr="\\cr.uni-frankfurt.de\homes\fb14\asfischer\Documents\Ongoing projects\PGE2 Hemmung Lukaste 5LOInhibitoren\WB protein expression\mPGES1 expression\180625\180625_Hela_5LOInhibitoren_mPGES1_Actin.tif"/>
                <p:cNvPicPr/>
                <p:nvPr/>
              </p:nvPicPr>
              <p:blipFill>
                <a:blip r:embed="rId9"/>
                <a:srcRect l="8000" t="32128" r="30269" b="57580"/>
                <a:stretch/>
              </p:blipFill>
              <p:spPr>
                <a:xfrm>
                  <a:off x="6520320" y="3526920"/>
                  <a:ext cx="2221560" cy="16668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69" name="Textfeld 9"/>
                <p:cNvSpPr/>
                <p:nvPr/>
              </p:nvSpPr>
              <p:spPr>
                <a:xfrm>
                  <a:off x="8641440" y="3515400"/>
                  <a:ext cx="5324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42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Textfeld 9"/>
                <p:cNvSpPr/>
                <p:nvPr/>
              </p:nvSpPr>
              <p:spPr>
                <a:xfrm>
                  <a:off x="8666280" y="3303000"/>
                  <a:ext cx="5083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0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6 kDa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1" name="Textfeld 15"/>
              <p:cNvSpPr/>
              <p:nvPr/>
            </p:nvSpPr>
            <p:spPr>
              <a:xfrm>
                <a:off x="3169440" y="3517560"/>
                <a:ext cx="53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l-GR" sz="700" spc="-1" strike="noStrike">
                    <a:solidFill>
                      <a:srgbClr val="000000"/>
                    </a:solidFill>
                    <a:latin typeface="Arial"/>
                  </a:rPr>
                  <a:t>β</a:t>
                </a: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-Actin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feld 15"/>
              <p:cNvSpPr/>
              <p:nvPr/>
            </p:nvSpPr>
            <p:spPr>
              <a:xfrm>
                <a:off x="6055200" y="3508560"/>
                <a:ext cx="531360" cy="200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el-GR" sz="700" spc="-1" strike="noStrike">
                    <a:solidFill>
                      <a:srgbClr val="000000"/>
                    </a:solidFill>
                    <a:latin typeface="Arial"/>
                  </a:rPr>
                  <a:t>β</a:t>
                </a:r>
                <a:r>
                  <a:rPr b="1" lang="de-DE" sz="700" spc="-1" strike="noStrike">
                    <a:solidFill>
                      <a:srgbClr val="000000"/>
                    </a:solidFill>
                    <a:latin typeface="Arial"/>
                  </a:rPr>
                  <a:t>-Actin </a:t>
                </a:r>
                <a:endParaRPr b="0" lang="en-US" sz="7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3" name="Gruppieren 5"/>
              <p:cNvGrpSpPr/>
              <p:nvPr/>
            </p:nvGrpSpPr>
            <p:grpSpPr>
              <a:xfrm>
                <a:off x="775440" y="3700080"/>
                <a:ext cx="2336040" cy="449640"/>
                <a:chOff x="775440" y="3700080"/>
                <a:chExt cx="2336040" cy="449640"/>
              </a:xfrm>
            </p:grpSpPr>
            <p:sp>
              <p:nvSpPr>
                <p:cNvPr id="74" name="Textfeld 5"/>
                <p:cNvSpPr/>
                <p:nvPr/>
              </p:nvSpPr>
              <p:spPr>
                <a:xfrm>
                  <a:off x="1115640" y="3700080"/>
                  <a:ext cx="19710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AA    CJ    BW   Dex            ND    C06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Textfeld 25"/>
                <p:cNvSpPr/>
                <p:nvPr/>
              </p:nvSpPr>
              <p:spPr>
                <a:xfrm>
                  <a:off x="898560" y="3703680"/>
                  <a:ext cx="3315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Zil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Textfeld 41"/>
                <p:cNvSpPr/>
                <p:nvPr/>
              </p:nvSpPr>
              <p:spPr>
                <a:xfrm>
                  <a:off x="928440" y="3827520"/>
                  <a:ext cx="3758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Textfeld 42"/>
                <p:cNvSpPr/>
                <p:nvPr/>
              </p:nvSpPr>
              <p:spPr>
                <a:xfrm>
                  <a:off x="2749320" y="3824640"/>
                  <a:ext cx="3621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[µM]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Textfeld 41"/>
                <p:cNvSpPr/>
                <p:nvPr/>
              </p:nvSpPr>
              <p:spPr>
                <a:xfrm>
                  <a:off x="1189440" y="3829680"/>
                  <a:ext cx="278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Textfeld 41"/>
                <p:cNvSpPr/>
                <p:nvPr/>
              </p:nvSpPr>
              <p:spPr>
                <a:xfrm>
                  <a:off x="1608840" y="3830760"/>
                  <a:ext cx="3027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3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Textfeld 41"/>
                <p:cNvSpPr/>
                <p:nvPr/>
              </p:nvSpPr>
              <p:spPr>
                <a:xfrm>
                  <a:off x="1386720" y="382608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0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Textfeld 41"/>
                <p:cNvSpPr/>
                <p:nvPr/>
              </p:nvSpPr>
              <p:spPr>
                <a:xfrm>
                  <a:off x="1842120" y="3826080"/>
                  <a:ext cx="502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Textfeld 41"/>
                <p:cNvSpPr/>
                <p:nvPr/>
              </p:nvSpPr>
              <p:spPr>
                <a:xfrm>
                  <a:off x="2264760" y="3826080"/>
                  <a:ext cx="3027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Textfeld 41"/>
                <p:cNvSpPr/>
                <p:nvPr/>
              </p:nvSpPr>
              <p:spPr>
                <a:xfrm>
                  <a:off x="2517120" y="3828960"/>
                  <a:ext cx="2538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Textfeld 4"/>
                <p:cNvSpPr/>
                <p:nvPr/>
              </p:nvSpPr>
              <p:spPr>
                <a:xfrm>
                  <a:off x="2746440" y="3944160"/>
                  <a:ext cx="3362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T/I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Textfeld 50"/>
                <p:cNvSpPr/>
                <p:nvPr/>
              </p:nvSpPr>
              <p:spPr>
                <a:xfrm>
                  <a:off x="775440" y="3949200"/>
                  <a:ext cx="19897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+       +       +       +      +       +       -        +       +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86" name="Gruppieren 87"/>
              <p:cNvGrpSpPr/>
              <p:nvPr/>
            </p:nvGrpSpPr>
            <p:grpSpPr>
              <a:xfrm>
                <a:off x="3684960" y="3700080"/>
                <a:ext cx="2336040" cy="449640"/>
                <a:chOff x="3684960" y="3700080"/>
                <a:chExt cx="2336040" cy="449640"/>
              </a:xfrm>
            </p:grpSpPr>
            <p:sp>
              <p:nvSpPr>
                <p:cNvPr id="87" name="Textfeld 5"/>
                <p:cNvSpPr/>
                <p:nvPr/>
              </p:nvSpPr>
              <p:spPr>
                <a:xfrm>
                  <a:off x="4025160" y="3700080"/>
                  <a:ext cx="19710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AA    CJ    BW   Dex            ND    C06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Textfeld 25"/>
                <p:cNvSpPr/>
                <p:nvPr/>
              </p:nvSpPr>
              <p:spPr>
                <a:xfrm>
                  <a:off x="3808080" y="3703680"/>
                  <a:ext cx="3315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Zil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Textfeld 41"/>
                <p:cNvSpPr/>
                <p:nvPr/>
              </p:nvSpPr>
              <p:spPr>
                <a:xfrm>
                  <a:off x="3837960" y="3827520"/>
                  <a:ext cx="3758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Textfeld 42"/>
                <p:cNvSpPr/>
                <p:nvPr/>
              </p:nvSpPr>
              <p:spPr>
                <a:xfrm>
                  <a:off x="5658840" y="3824640"/>
                  <a:ext cx="3621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[µM]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Textfeld 41"/>
                <p:cNvSpPr/>
                <p:nvPr/>
              </p:nvSpPr>
              <p:spPr>
                <a:xfrm>
                  <a:off x="4098960" y="3829680"/>
                  <a:ext cx="278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Textfeld 41"/>
                <p:cNvSpPr/>
                <p:nvPr/>
              </p:nvSpPr>
              <p:spPr>
                <a:xfrm>
                  <a:off x="4518360" y="3830760"/>
                  <a:ext cx="3027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3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Textfeld 41"/>
                <p:cNvSpPr/>
                <p:nvPr/>
              </p:nvSpPr>
              <p:spPr>
                <a:xfrm>
                  <a:off x="4296240" y="382608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0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Textfeld 41"/>
                <p:cNvSpPr/>
                <p:nvPr/>
              </p:nvSpPr>
              <p:spPr>
                <a:xfrm>
                  <a:off x="4751640" y="3826080"/>
                  <a:ext cx="502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Textfeld 41"/>
                <p:cNvSpPr/>
                <p:nvPr/>
              </p:nvSpPr>
              <p:spPr>
                <a:xfrm>
                  <a:off x="5174280" y="3826080"/>
                  <a:ext cx="3027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Textfeld 41"/>
                <p:cNvSpPr/>
                <p:nvPr/>
              </p:nvSpPr>
              <p:spPr>
                <a:xfrm>
                  <a:off x="5426640" y="3828960"/>
                  <a:ext cx="25380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Textfeld 4"/>
                <p:cNvSpPr/>
                <p:nvPr/>
              </p:nvSpPr>
              <p:spPr>
                <a:xfrm>
                  <a:off x="5655960" y="3944160"/>
                  <a:ext cx="3362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T/I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Textfeld 50"/>
                <p:cNvSpPr/>
                <p:nvPr/>
              </p:nvSpPr>
              <p:spPr>
                <a:xfrm>
                  <a:off x="3684960" y="3949200"/>
                  <a:ext cx="19897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+       +       +       +      +       +       -        +       +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9" name="Gruppieren 100"/>
              <p:cNvGrpSpPr/>
              <p:nvPr/>
            </p:nvGrpSpPr>
            <p:grpSpPr>
              <a:xfrm>
                <a:off x="6579000" y="3700440"/>
                <a:ext cx="2445840" cy="449640"/>
                <a:chOff x="6579000" y="3700440"/>
                <a:chExt cx="2445840" cy="449640"/>
              </a:xfrm>
            </p:grpSpPr>
            <p:sp>
              <p:nvSpPr>
                <p:cNvPr id="100" name="Textfeld 5"/>
                <p:cNvSpPr/>
                <p:nvPr/>
              </p:nvSpPr>
              <p:spPr>
                <a:xfrm>
                  <a:off x="6929280" y="3700440"/>
                  <a:ext cx="1971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AA     CJ    BW    Dex             ND    C06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Textfeld 25"/>
                <p:cNvSpPr/>
                <p:nvPr/>
              </p:nvSpPr>
              <p:spPr>
                <a:xfrm>
                  <a:off x="6712200" y="3704040"/>
                  <a:ext cx="3315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Zil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Textfeld 41"/>
                <p:cNvSpPr/>
                <p:nvPr/>
              </p:nvSpPr>
              <p:spPr>
                <a:xfrm>
                  <a:off x="6742440" y="3827880"/>
                  <a:ext cx="3758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  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Textfeld 42"/>
                <p:cNvSpPr/>
                <p:nvPr/>
              </p:nvSpPr>
              <p:spPr>
                <a:xfrm>
                  <a:off x="8662680" y="3831120"/>
                  <a:ext cx="3621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[µM]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Textfeld 41"/>
                <p:cNvSpPr/>
                <p:nvPr/>
              </p:nvSpPr>
              <p:spPr>
                <a:xfrm>
                  <a:off x="7003080" y="3830040"/>
                  <a:ext cx="278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Textfeld 41"/>
                <p:cNvSpPr/>
                <p:nvPr/>
              </p:nvSpPr>
              <p:spPr>
                <a:xfrm>
                  <a:off x="7423560" y="3831120"/>
                  <a:ext cx="3268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3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Textfeld 41"/>
                <p:cNvSpPr/>
                <p:nvPr/>
              </p:nvSpPr>
              <p:spPr>
                <a:xfrm>
                  <a:off x="7201080" y="3826440"/>
                  <a:ext cx="351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20  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Textfeld 41"/>
                <p:cNvSpPr/>
                <p:nvPr/>
              </p:nvSpPr>
              <p:spPr>
                <a:xfrm>
                  <a:off x="7655760" y="3826440"/>
                  <a:ext cx="50292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Textfeld 41"/>
                <p:cNvSpPr/>
                <p:nvPr/>
              </p:nvSpPr>
              <p:spPr>
                <a:xfrm>
                  <a:off x="8080560" y="3826440"/>
                  <a:ext cx="3758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 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Textfeld 41"/>
                <p:cNvSpPr/>
                <p:nvPr/>
              </p:nvSpPr>
              <p:spPr>
                <a:xfrm>
                  <a:off x="8333640" y="3829320"/>
                  <a:ext cx="35136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     </a:t>
                  </a: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Textfeld 4"/>
                <p:cNvSpPr/>
                <p:nvPr/>
              </p:nvSpPr>
              <p:spPr>
                <a:xfrm>
                  <a:off x="8664120" y="3944520"/>
                  <a:ext cx="33624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T/IL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Textfeld 50"/>
                <p:cNvSpPr/>
                <p:nvPr/>
              </p:nvSpPr>
              <p:spPr>
                <a:xfrm>
                  <a:off x="6579000" y="3949560"/>
                  <a:ext cx="2087280" cy="200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700" spc="-1" strike="noStrike">
                      <a:solidFill>
                        <a:srgbClr val="000000"/>
                      </a:solidFill>
                      <a:latin typeface="Arial"/>
                    </a:rPr>
                    <a:t>+       +       +       +        +       +        -        +        +</a:t>
                  </a:r>
                  <a:endParaRPr b="0" lang="en-US" sz="7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2" name="Textfeld 15"/>
              <p:cNvSpPr/>
              <p:nvPr/>
            </p:nvSpPr>
            <p:spPr>
              <a:xfrm>
                <a:off x="168840" y="1705320"/>
                <a:ext cx="24372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A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feld 15"/>
              <p:cNvSpPr/>
              <p:nvPr/>
            </p:nvSpPr>
            <p:spPr>
              <a:xfrm>
                <a:off x="3082680" y="1704600"/>
                <a:ext cx="325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B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feld 15"/>
              <p:cNvSpPr/>
              <p:nvPr/>
            </p:nvSpPr>
            <p:spPr>
              <a:xfrm>
                <a:off x="5949360" y="1701720"/>
                <a:ext cx="32508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4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15" name="Rechteck 68"/>
          <p:cNvSpPr/>
          <p:nvPr/>
        </p:nvSpPr>
        <p:spPr>
          <a:xfrm>
            <a:off x="203040" y="4268880"/>
            <a:ext cx="8825040" cy="1421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01"/>
              </a:spcBef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Supplementary Figure 1: Expression of enzymes involved in PGE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  <a:ea typeface="Calibri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biosynthesis in HeLa cell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HeLa cells were treated with cytokines (IL-1α 1 ng•m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, TNFα 5 ng•m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) and the inhibitors AA-861 (2 µM), zileuton (10 µM), CJ-13,610 (20 µM), BWA4C (3 µM), NDGA 10 µM) or C06 (5 µM) for 16 h. 1 µM dexamethasone served as positive control. Thereafter, Western blotting of the cell lysates was performed and expression of cPLA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Calibri"/>
              </a:rPr>
              <a:t>2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, COX-2 and mPGES-1 was determined by immunostaining. For detailed methodical description, see the Materials and Methods section. Values represent the mean + SD of three independent experiments. T/IL, IL-1β/TNFα; AA, AA-861; BW, BWA4C; CJ, CJ-16,310; Dex, dexamethasone; ND, NDGA; Zil, zileuton; ns, not significant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6" name="Gruppieren 3"/>
          <p:cNvGrpSpPr/>
          <p:nvPr/>
        </p:nvGrpSpPr>
        <p:grpSpPr>
          <a:xfrm>
            <a:off x="131760" y="1413000"/>
            <a:ext cx="8982000" cy="3361320"/>
            <a:chOff x="131760" y="1413000"/>
            <a:chExt cx="8982000" cy="3361320"/>
          </a:xfrm>
        </p:grpSpPr>
        <p:sp>
          <p:nvSpPr>
            <p:cNvPr id="117" name="Rechteck 3"/>
            <p:cNvSpPr/>
            <p:nvPr/>
          </p:nvSpPr>
          <p:spPr>
            <a:xfrm>
              <a:off x="131760" y="1413000"/>
              <a:ext cx="8982000" cy="33112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feld 3"/>
            <p:cNvSpPr/>
            <p:nvPr/>
          </p:nvSpPr>
          <p:spPr>
            <a:xfrm>
              <a:off x="162360" y="1478160"/>
              <a:ext cx="3275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8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pplementary Figure 2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9" name="Picture 25" descr="\\cr.uni-frankfurt.de\homes\fb14\asfischer\Documents\Ongoing projects\PGE2 Hemmung Lukaste 5LOInhibitoren\COX Activity Assay\COX-1 Assay 5-LO inhib SD.tif"/>
            <p:cNvPicPr/>
            <p:nvPr/>
          </p:nvPicPr>
          <p:blipFill>
            <a:blip r:embed="rId1"/>
            <a:stretch/>
          </p:blipFill>
          <p:spPr>
            <a:xfrm>
              <a:off x="178920" y="2145960"/>
              <a:ext cx="2801160" cy="2337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20" name="Picture 26" descr="\\cr.uni-frankfurt.de\homes\fb14\asfischer\Documents\Ongoing projects\PGE2 Hemmung Lukaste 5LOInhibitoren\COX Activity Assay\COX-2 Assay 5-LO inhib SD.tif"/>
            <p:cNvPicPr/>
            <p:nvPr/>
          </p:nvPicPr>
          <p:blipFill>
            <a:blip r:embed="rId2"/>
            <a:stretch/>
          </p:blipFill>
          <p:spPr>
            <a:xfrm>
              <a:off x="3016080" y="2111040"/>
              <a:ext cx="2852280" cy="2195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1" name="Textfeld 3"/>
            <p:cNvSpPr/>
            <p:nvPr/>
          </p:nvSpPr>
          <p:spPr>
            <a:xfrm>
              <a:off x="2924640" y="1946160"/>
              <a:ext cx="4316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feld 3"/>
            <p:cNvSpPr/>
            <p:nvPr/>
          </p:nvSpPr>
          <p:spPr>
            <a:xfrm>
              <a:off x="131760" y="1946160"/>
              <a:ext cx="4791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23" name="Picture 25" descr="\\cr.uni-frankfurt.de\homes\fb14\asfischer\Documents\Ongoing projects\PGE2 Hemmung Lukaste 5LOInhibitoren\WB protein expression\15-PGDH.tif"/>
            <p:cNvPicPr/>
            <p:nvPr/>
          </p:nvPicPr>
          <p:blipFill>
            <a:blip r:embed="rId3"/>
            <a:stretch/>
          </p:blipFill>
          <p:spPr>
            <a:xfrm>
              <a:off x="5843520" y="2134440"/>
              <a:ext cx="2835720" cy="1551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4" name="Textfeld 5"/>
            <p:cNvSpPr/>
            <p:nvPr/>
          </p:nvSpPr>
          <p:spPr>
            <a:xfrm>
              <a:off x="6851880" y="4156920"/>
              <a:ext cx="18273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ND  C06  Dex  Zil   AA   BW   CJ       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feld 25"/>
            <p:cNvSpPr/>
            <p:nvPr/>
          </p:nvSpPr>
          <p:spPr>
            <a:xfrm>
              <a:off x="6501600" y="4437000"/>
              <a:ext cx="24717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      +       +     +       +      +     +       +      +      T/IL    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feld 42"/>
            <p:cNvSpPr/>
            <p:nvPr/>
          </p:nvSpPr>
          <p:spPr>
            <a:xfrm>
              <a:off x="8579160" y="4283280"/>
              <a:ext cx="392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[µM]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feld 41"/>
            <p:cNvSpPr/>
            <p:nvPr/>
          </p:nvSpPr>
          <p:spPr>
            <a:xfrm>
              <a:off x="6926400" y="4310640"/>
              <a:ext cx="351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Textfeld 41"/>
            <p:cNvSpPr/>
            <p:nvPr/>
          </p:nvSpPr>
          <p:spPr>
            <a:xfrm>
              <a:off x="7421400" y="4310640"/>
              <a:ext cx="295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feld 41"/>
            <p:cNvSpPr/>
            <p:nvPr/>
          </p:nvSpPr>
          <p:spPr>
            <a:xfrm>
              <a:off x="7159320" y="4310640"/>
              <a:ext cx="295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feld 41"/>
            <p:cNvSpPr/>
            <p:nvPr/>
          </p:nvSpPr>
          <p:spPr>
            <a:xfrm>
              <a:off x="7611120" y="4310640"/>
              <a:ext cx="32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feld 41"/>
            <p:cNvSpPr/>
            <p:nvPr/>
          </p:nvSpPr>
          <p:spPr>
            <a:xfrm>
              <a:off x="8105400" y="4310640"/>
              <a:ext cx="237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feld 41"/>
            <p:cNvSpPr/>
            <p:nvPr/>
          </p:nvSpPr>
          <p:spPr>
            <a:xfrm>
              <a:off x="8304480" y="4310640"/>
              <a:ext cx="293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feld 41"/>
            <p:cNvSpPr/>
            <p:nvPr/>
          </p:nvSpPr>
          <p:spPr>
            <a:xfrm>
              <a:off x="7857000" y="4310640"/>
              <a:ext cx="668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2 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Textfeld 17"/>
            <p:cNvSpPr/>
            <p:nvPr/>
          </p:nvSpPr>
          <p:spPr>
            <a:xfrm>
              <a:off x="8548200" y="394560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42 kD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Textfeld 17"/>
            <p:cNvSpPr/>
            <p:nvPr/>
          </p:nvSpPr>
          <p:spPr>
            <a:xfrm>
              <a:off x="8548200" y="3675960"/>
              <a:ext cx="561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56 kDa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6" name="Picture 6" descr="U:\Eigene Dateien\Ongoing projects\PGE2 Hemmung Lukaste 5LOInhibitoren\WB protein expression\15PGDH expression\140728_BII_15PGDH_sw.tif.tif"/>
            <p:cNvPicPr/>
            <p:nvPr/>
          </p:nvPicPr>
          <p:blipFill>
            <a:blip r:embed="rId4">
              <a:lum bright="40000"/>
            </a:blip>
            <a:srcRect l="4854" t="43273" r="18672" b="45950"/>
            <a:stretch/>
          </p:blipFill>
          <p:spPr>
            <a:xfrm flipH="1" rot="10800000">
              <a:off x="6419160" y="3663720"/>
              <a:ext cx="2188080" cy="2196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37" name="Picture 7" descr="U:\Eigene Dateien\Ongoing projects\PGE2 Hemmung Lukaste 5LOInhibitoren\WB protein expression\15PGDH expression\140730_BII_bActin_sw.tif.tif"/>
            <p:cNvPicPr/>
            <p:nvPr/>
          </p:nvPicPr>
          <p:blipFill>
            <a:blip r:embed="rId5"/>
            <a:srcRect l="6446" t="69495" r="15836" b="24067"/>
            <a:stretch/>
          </p:blipFill>
          <p:spPr>
            <a:xfrm flipH="1" rot="10800000">
              <a:off x="6420240" y="3947400"/>
              <a:ext cx="2187360" cy="2214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38" name="Textfeld 17"/>
            <p:cNvSpPr/>
            <p:nvPr/>
          </p:nvSpPr>
          <p:spPr>
            <a:xfrm>
              <a:off x="5871240" y="3944520"/>
              <a:ext cx="560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l-G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β</a:t>
              </a:r>
              <a:r>
                <a:rPr b="1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Acti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Textfeld 17"/>
            <p:cNvSpPr/>
            <p:nvPr/>
          </p:nvSpPr>
          <p:spPr>
            <a:xfrm>
              <a:off x="5937480" y="3659760"/>
              <a:ext cx="502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(dimer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feld 3"/>
            <p:cNvSpPr/>
            <p:nvPr/>
          </p:nvSpPr>
          <p:spPr>
            <a:xfrm>
              <a:off x="5671080" y="1946160"/>
              <a:ext cx="509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ff0000"/>
                  </a:solidFill>
                  <a:latin typeface="Arial"/>
                </a:rPr>
                <a:t> </a:t>
              </a: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1" name="Rechteck 27"/>
          <p:cNvSpPr/>
          <p:nvPr/>
        </p:nvSpPr>
        <p:spPr>
          <a:xfrm>
            <a:off x="250920" y="4707000"/>
            <a:ext cx="8723160" cy="16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01"/>
              </a:spcBef>
              <a:spcAft>
                <a:spcPts val="1199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Supplementary Figure 2: Influence on the activities of purified COX isoenzymes and 15-PGDH protein expression in HeLa cells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The inhibitors were tested for direct inhibition of ovine COX-1 (A) or recombinant human COX-2 (B). PGH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Calibri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formed during the reaction was reduced by stannous chloride to PGF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Arial"/>
                <a:ea typeface="Calibri"/>
              </a:rPr>
              <a:t>2α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 afterwards and analyzed via ELISA. (C) HeLa cells were treated with cytokines (IL-1β 1 ng•m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, TNFα 5 ng•mL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  <a:ea typeface="Calibri"/>
              </a:rPr>
              <a:t>-1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Calibri"/>
              </a:rPr>
              <a:t>) and the inhibitors (2 µM AA-861, 10 µM zileuton, 20 µM CJ-13,610, 3 µM BWA4C, 10 µM NDGA, 5 µM C06, 1 µM dexamethasone) or vehicle (DMSO) for 16 h and expression of 15-PGDH was evaluated by Western blotting. For detailed methodical description, see the Materials and Methods section. Values represent mean + SD of three (A,B) or four (C) independent experiments. AA, AA-861; BW, BWA4C; CJ, CJ-16,310; Dex, dexamethasone; ND, NDGA; Ro, rofecoxib; SC, sc-560; T/IL, IL-1β/TNFα; Zil, zileuton. *, p≤ 0.05; **, p ≤ 0.01; ***, p ≤ 0.001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5-06T07:59:55Z</dcterms:created>
  <dc:creator>Thorsten Maier</dc:creator>
  <dc:description/>
  <dc:language>en-US</dc:language>
  <cp:lastModifiedBy>Astrid Fischer</cp:lastModifiedBy>
  <dcterms:modified xsi:type="dcterms:W3CDTF">2021-12-02T12:21:13Z</dcterms:modified>
  <cp:revision>99</cp:revision>
  <dc:subject/>
  <dc:title>Folie 1</dc:title>
</cp:coreProperties>
</file>